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938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4285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9525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0301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089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3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8234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367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178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8439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3115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751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74E092-BAB0-4523-B23A-9192F3313913}" type="datetimeFigureOut">
              <a:rPr lang="en-US" smtClean="0"/>
              <a:t>4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DF1646-631B-4BD1-B1D9-A2293CDB3B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232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10993293"/>
              </p:ext>
            </p:extLst>
          </p:nvPr>
        </p:nvGraphicFramePr>
        <p:xfrm>
          <a:off x="3153038" y="3451703"/>
          <a:ext cx="2504206" cy="21735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8" name="Prism 7" r:id="rId3" imgW="3228977" imgH="2899960" progId="Prism7.Document">
                  <p:embed/>
                </p:oleObj>
              </mc:Choice>
              <mc:Fallback>
                <p:oleObj name="Prism 7" r:id="rId3" imgW="3228977" imgH="28999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53038" y="3451703"/>
                        <a:ext cx="2504206" cy="21735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7630118"/>
              </p:ext>
            </p:extLst>
          </p:nvPr>
        </p:nvGraphicFramePr>
        <p:xfrm>
          <a:off x="5973763" y="3581401"/>
          <a:ext cx="2475979" cy="20141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99" name="Prism 7" r:id="rId5" imgW="3228977" imgH="2899960" progId="Prism7.Document">
                  <p:embed/>
                </p:oleObj>
              </mc:Choice>
              <mc:Fallback>
                <p:oleObj name="Prism 7" r:id="rId5" imgW="3228977" imgH="28999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973763" y="3581401"/>
                        <a:ext cx="2475979" cy="20141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5918171"/>
              </p:ext>
            </p:extLst>
          </p:nvPr>
        </p:nvGraphicFramePr>
        <p:xfrm>
          <a:off x="635000" y="1201738"/>
          <a:ext cx="2188299" cy="18474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0" name="Prism 7" r:id="rId7" imgW="2972920" imgH="2381339" progId="Prism7.Document">
                  <p:embed/>
                </p:oleObj>
              </mc:Choice>
              <mc:Fallback>
                <p:oleObj name="Prism 7" r:id="rId7" imgW="2972920" imgH="2381339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35000" y="1201738"/>
                        <a:ext cx="2188299" cy="18474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itle 1"/>
          <p:cNvSpPr txBox="1">
            <a:spLocks/>
          </p:cNvSpPr>
          <p:nvPr/>
        </p:nvSpPr>
        <p:spPr>
          <a:xfrm rot="16200000">
            <a:off x="-324819" y="2055143"/>
            <a:ext cx="1417714" cy="159794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% survival</a:t>
            </a:r>
          </a:p>
        </p:txBody>
      </p:sp>
      <p:sp>
        <p:nvSpPr>
          <p:cNvPr id="29" name="Title 1"/>
          <p:cNvSpPr txBox="1">
            <a:spLocks/>
          </p:cNvSpPr>
          <p:nvPr/>
        </p:nvSpPr>
        <p:spPr>
          <a:xfrm>
            <a:off x="1257219" y="3124459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45781" y="1055765"/>
            <a:ext cx="20694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ay 7 Survival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2676376"/>
              </p:ext>
            </p:extLst>
          </p:nvPr>
        </p:nvGraphicFramePr>
        <p:xfrm>
          <a:off x="434531" y="3606951"/>
          <a:ext cx="2519778" cy="20596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1" name="Prism 7" r:id="rId9" imgW="3228977" imgH="2625523" progId="Prism7.Document">
                  <p:embed/>
                </p:oleObj>
              </mc:Choice>
              <mc:Fallback>
                <p:oleObj name="Prism 7" r:id="rId9" imgW="3228977" imgH="262552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34531" y="3606951"/>
                        <a:ext cx="2519778" cy="20596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itle 1"/>
          <p:cNvSpPr txBox="1">
            <a:spLocks/>
          </p:cNvSpPr>
          <p:nvPr/>
        </p:nvSpPr>
        <p:spPr>
          <a:xfrm>
            <a:off x="1221058" y="5559580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 rot="16200000">
            <a:off x="94574" y="4414230"/>
            <a:ext cx="578926" cy="30411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45781" y="3551856"/>
            <a:ext cx="266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nd-Diastolic Dimensions</a:t>
            </a:r>
          </a:p>
        </p:txBody>
      </p: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960170"/>
              </p:ext>
            </p:extLst>
          </p:nvPr>
        </p:nvGraphicFramePr>
        <p:xfrm>
          <a:off x="5981700" y="1181100"/>
          <a:ext cx="2315200" cy="19925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2" name="Prism 7" r:id="rId11" imgW="3228977" imgH="2899960" progId="Prism7.Document">
                  <p:embed/>
                </p:oleObj>
              </mc:Choice>
              <mc:Fallback>
                <p:oleObj name="Prism 7" r:id="rId11" imgW="3228977" imgH="289996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981700" y="1181100"/>
                        <a:ext cx="2315200" cy="199255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itle 1"/>
          <p:cNvSpPr txBox="1">
            <a:spLocks/>
          </p:cNvSpPr>
          <p:nvPr/>
        </p:nvSpPr>
        <p:spPr>
          <a:xfrm rot="16200000">
            <a:off x="5317321" y="2109981"/>
            <a:ext cx="968138" cy="245656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4017644" y="5559580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185073" y="1055765"/>
            <a:ext cx="23795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V Wall Thicknes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6071554" y="3551856"/>
            <a:ext cx="230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ractional Shortening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3778437"/>
              </p:ext>
            </p:extLst>
          </p:nvPr>
        </p:nvGraphicFramePr>
        <p:xfrm>
          <a:off x="3173413" y="1265238"/>
          <a:ext cx="2405823" cy="19589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3" name="Prism 7" r:id="rId13" imgW="3228977" imgH="2625523" progId="Prism7.Document">
                  <p:embed/>
                </p:oleObj>
              </mc:Choice>
              <mc:Fallback>
                <p:oleObj name="Prism 7" r:id="rId13" imgW="3228977" imgH="262552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173413" y="1265238"/>
                        <a:ext cx="2405823" cy="19589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itle 1"/>
          <p:cNvSpPr txBox="1">
            <a:spLocks/>
          </p:cNvSpPr>
          <p:nvPr/>
        </p:nvSpPr>
        <p:spPr>
          <a:xfrm>
            <a:off x="4017644" y="3119382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276274" y="1055765"/>
            <a:ext cx="22598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nfarct Size (Weight)</a:t>
            </a:r>
          </a:p>
        </p:txBody>
      </p:sp>
      <p:sp>
        <p:nvSpPr>
          <p:cNvPr id="39" name="Title 1"/>
          <p:cNvSpPr txBox="1">
            <a:spLocks/>
          </p:cNvSpPr>
          <p:nvPr/>
        </p:nvSpPr>
        <p:spPr>
          <a:xfrm rot="16200000">
            <a:off x="2656518" y="2102604"/>
            <a:ext cx="968139" cy="245656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g</a:t>
            </a:r>
          </a:p>
        </p:txBody>
      </p:sp>
      <p:sp>
        <p:nvSpPr>
          <p:cNvPr id="40" name="Title 1"/>
          <p:cNvSpPr txBox="1">
            <a:spLocks/>
          </p:cNvSpPr>
          <p:nvPr/>
        </p:nvSpPr>
        <p:spPr>
          <a:xfrm>
            <a:off x="40514" y="39664"/>
            <a:ext cx="3037164" cy="356071"/>
          </a:xfrm>
          <a:prstGeom prst="rect">
            <a:avLst/>
          </a:prstGeom>
        </p:spPr>
        <p:txBody>
          <a:bodyPr vert="horz" lIns="68580" tIns="34291" rIns="68580" bIns="34291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itle 1"/>
          <p:cNvSpPr txBox="1">
            <a:spLocks/>
          </p:cNvSpPr>
          <p:nvPr/>
        </p:nvSpPr>
        <p:spPr>
          <a:xfrm>
            <a:off x="6698273" y="3119382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961733" y="1950374"/>
            <a:ext cx="15131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6% (15/27)</a:t>
            </a:r>
          </a:p>
        </p:txBody>
      </p:sp>
      <p:cxnSp>
        <p:nvCxnSpPr>
          <p:cNvPr id="73" name="Straight Connector 72"/>
          <p:cNvCxnSpPr/>
          <p:nvPr/>
        </p:nvCxnSpPr>
        <p:spPr>
          <a:xfrm>
            <a:off x="3689775" y="1871410"/>
            <a:ext cx="7305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4487483" y="1871406"/>
            <a:ext cx="7305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656642" y="1597198"/>
            <a:ext cx="9161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0.97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4504529" y="1597198"/>
            <a:ext cx="10225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0.60</a:t>
            </a:r>
          </a:p>
        </p:txBody>
      </p:sp>
      <p:cxnSp>
        <p:nvCxnSpPr>
          <p:cNvPr id="77" name="Straight Connector 76"/>
          <p:cNvCxnSpPr/>
          <p:nvPr/>
        </p:nvCxnSpPr>
        <p:spPr>
          <a:xfrm>
            <a:off x="3689775" y="1571268"/>
            <a:ext cx="14550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/>
          <p:cNvSpPr txBox="1"/>
          <p:nvPr/>
        </p:nvSpPr>
        <p:spPr>
          <a:xfrm>
            <a:off x="4025733" y="1289912"/>
            <a:ext cx="916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=0.75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6850495" y="185111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7300097" y="185111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7739436" y="185111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383745" y="4422785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1893232" y="431853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2184248" y="4006987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2340598" y="3998734"/>
            <a:ext cx="33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2492850" y="4006987"/>
            <a:ext cx="33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17" name="Title 1"/>
          <p:cNvSpPr txBox="1">
            <a:spLocks/>
          </p:cNvSpPr>
          <p:nvPr/>
        </p:nvSpPr>
        <p:spPr>
          <a:xfrm rot="16200000">
            <a:off x="5087241" y="4226363"/>
            <a:ext cx="1428298" cy="32720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ercent(%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276272" y="3551856"/>
            <a:ext cx="34084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nd-Systolic Dimensions</a:t>
            </a:r>
          </a:p>
        </p:txBody>
      </p:sp>
      <p:sp>
        <p:nvSpPr>
          <p:cNvPr id="51" name="Title 1"/>
          <p:cNvSpPr txBox="1">
            <a:spLocks/>
          </p:cNvSpPr>
          <p:nvPr/>
        </p:nvSpPr>
        <p:spPr>
          <a:xfrm rot="16200000">
            <a:off x="2851124" y="4399467"/>
            <a:ext cx="578926" cy="30411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4099547" y="4350752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4600280" y="4296323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4910241" y="3983161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5066591" y="3974908"/>
            <a:ext cx="33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5218843" y="3983161"/>
            <a:ext cx="3325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$</a:t>
            </a:r>
          </a:p>
        </p:txBody>
      </p:sp>
      <p:sp>
        <p:nvSpPr>
          <p:cNvPr id="101" name="Title 1"/>
          <p:cNvSpPr txBox="1">
            <a:spLocks/>
          </p:cNvSpPr>
          <p:nvPr/>
        </p:nvSpPr>
        <p:spPr>
          <a:xfrm>
            <a:off x="6757394" y="5559580"/>
            <a:ext cx="1097280" cy="246885"/>
          </a:xfrm>
          <a:prstGeom prst="rect">
            <a:avLst/>
          </a:prstGeom>
        </p:spPr>
        <p:txBody>
          <a:bodyPr vert="horz" lIns="68580" tIns="34291" rIns="68580" bIns="34291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ays post-MI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6900804" y="4635252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7395554" y="4635252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7863457" y="4635252"/>
            <a:ext cx="3518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94332" y="1489321"/>
            <a:ext cx="5858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78195" y="2103301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70962" y="273230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83145" y="29173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453063" y="29173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023611" y="29173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613539" y="29173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734206" y="2912820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4345030" y="2912820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960954" y="2912820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127240" y="2528505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127240" y="2081008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127240" y="1618550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6856275" y="2884234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7301824" y="2884234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7768875" y="2884234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6421651" y="2884234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5847937" y="2735463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819656" y="2122641"/>
            <a:ext cx="4373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819656" y="1498626"/>
            <a:ext cx="4373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401408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1887901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2395896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925840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89194" y="51635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89194" y="470319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89194" y="4236078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89194" y="378538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193301" y="516355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193301" y="470319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193301" y="4249726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193301" y="3785383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128910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4615403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5123398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653342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5855973" y="4746764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855973" y="4327475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855973" y="3904274"/>
            <a:ext cx="4090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6015576" y="5169037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6901493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18" name="TextBox 117"/>
          <p:cNvSpPr txBox="1"/>
          <p:nvPr/>
        </p:nvSpPr>
        <p:spPr>
          <a:xfrm>
            <a:off x="7387986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7895981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6425925" y="5339019"/>
            <a:ext cx="2494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12307225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126</Words>
  <Application>Microsoft Office PowerPoint</Application>
  <PresentationFormat>On-screen Show (4:3)</PresentationFormat>
  <Paragraphs>8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7</vt:lpstr>
      <vt:lpstr>PowerPoint Presentation</vt:lpstr>
    </vt:vector>
  </TitlesOfParts>
  <Company>U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Mouton</dc:creator>
  <cp:lastModifiedBy>Merry Lindsey</cp:lastModifiedBy>
  <cp:revision>10</cp:revision>
  <dcterms:created xsi:type="dcterms:W3CDTF">2018-03-06T20:13:48Z</dcterms:created>
  <dcterms:modified xsi:type="dcterms:W3CDTF">2018-04-03T23:48:07Z</dcterms:modified>
</cp:coreProperties>
</file>